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347" r:id="rId2"/>
    <p:sldId id="345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408"/>
    <p:restoredTop sz="95872"/>
  </p:normalViewPr>
  <p:slideViewPr>
    <p:cSldViewPr snapToGrid="0">
      <p:cViewPr varScale="1">
        <p:scale>
          <a:sx n="121" d="100"/>
          <a:sy n="121" d="100"/>
        </p:scale>
        <p:origin x="213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DAFB1D-35F6-614B-A23F-6D438DD0A8C5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6F909B-C235-9B4A-8B30-901BFAC0B2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0617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DDB930B-1E00-A64B-8BFD-D522F4F347D3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34" charset="-128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34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30946161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DDB930B-1E00-A64B-8BFD-D522F4F347D3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34" charset="-128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34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7279862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49870-5D80-544E-BAD9-0C83BF6BF2D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62EE8-1F30-C140-BE8F-75CF70362B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68191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49870-5D80-544E-BAD9-0C83BF6BF2D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62EE8-1F30-C140-BE8F-75CF70362B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02257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49870-5D80-544E-BAD9-0C83BF6BF2D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62EE8-1F30-C140-BE8F-75CF70362B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08355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49870-5D80-544E-BAD9-0C83BF6BF2D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62EE8-1F30-C140-BE8F-75CF70362B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2120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49870-5D80-544E-BAD9-0C83BF6BF2D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62EE8-1F30-C140-BE8F-75CF70362B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96833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49870-5D80-544E-BAD9-0C83BF6BF2D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62EE8-1F30-C140-BE8F-75CF70362B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0343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49870-5D80-544E-BAD9-0C83BF6BF2D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62EE8-1F30-C140-BE8F-75CF70362B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43292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49870-5D80-544E-BAD9-0C83BF6BF2D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62EE8-1F30-C140-BE8F-75CF70362B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18592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49870-5D80-544E-BAD9-0C83BF6BF2D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62EE8-1F30-C140-BE8F-75CF70362B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68052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49870-5D80-544E-BAD9-0C83BF6BF2D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62EE8-1F30-C140-BE8F-75CF70362B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8307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049870-5D80-544E-BAD9-0C83BF6BF2D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262EE8-1F30-C140-BE8F-75CF70362B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82363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049870-5D80-544E-BAD9-0C83BF6BF2D4}" type="datetimeFigureOut">
              <a:rPr kumimoji="1" lang="ja-JP" altLang="en-US" smtClean="0"/>
              <a:t>2022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262EE8-1F30-C140-BE8F-75CF70362B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75704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7" Type="http://schemas.openxmlformats.org/officeDocument/2006/relationships/image" Target="../media/image10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JPG"/><Relationship Id="rId5" Type="http://schemas.openxmlformats.org/officeDocument/2006/relationships/image" Target="../media/image8.JPG"/><Relationship Id="rId4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67E8ED60-78BF-ED4E-9214-4A62B823EB7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048101" y="1385273"/>
            <a:ext cx="2721180" cy="2247544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D9152268-0942-3C46-8736-23215AC5706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3315" r="11625" b="28100"/>
          <a:stretch/>
        </p:blipFill>
        <p:spPr>
          <a:xfrm>
            <a:off x="6388211" y="1366411"/>
            <a:ext cx="2518385" cy="2290863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031E0A3-2073-C548-B8A9-4FB5D9CFC786}"/>
              </a:ext>
            </a:extLst>
          </p:cNvPr>
          <p:cNvSpPr txBox="1"/>
          <p:nvPr/>
        </p:nvSpPr>
        <p:spPr>
          <a:xfrm>
            <a:off x="6706919" y="652255"/>
            <a:ext cx="199574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2000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Cooling in running water</a:t>
            </a:r>
            <a:endParaRPr kumimoji="1" lang="ja-JP" altLang="en-US" sz="2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D0E51460-2936-8843-8369-3A97421C4F32}"/>
              </a:ext>
            </a:extLst>
          </p:cNvPr>
          <p:cNvSpPr txBox="1"/>
          <p:nvPr/>
        </p:nvSpPr>
        <p:spPr>
          <a:xfrm>
            <a:off x="3206335" y="672551"/>
            <a:ext cx="256294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ja-JP" sz="2000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S</a:t>
            </a:r>
            <a:r>
              <a:rPr kumimoji="0" lang="en" altLang="ja-JP" sz="2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urface</a:t>
            </a:r>
            <a:r>
              <a:rPr kumimoji="0" lang="en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 sterilization at 60</a:t>
            </a:r>
            <a:r>
              <a:rPr kumimoji="0" lang="en" altLang="ja-JP" sz="20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o</a:t>
            </a:r>
            <a:r>
              <a:rPr kumimoji="0" lang="en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C for 10 min</a:t>
            </a:r>
            <a:endParaRPr kumimoji="1" lang="ja-JP" altLang="en-US" sz="2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9" name="右矢印 18">
            <a:extLst>
              <a:ext uri="{FF2B5EF4-FFF2-40B4-BE49-F238E27FC236}">
                <a16:creationId xmlns:a16="http://schemas.microsoft.com/office/drawing/2014/main" id="{7A098285-5939-BB40-B22D-DB29A9A0B02D}"/>
              </a:ext>
            </a:extLst>
          </p:cNvPr>
          <p:cNvSpPr/>
          <p:nvPr/>
        </p:nvSpPr>
        <p:spPr>
          <a:xfrm>
            <a:off x="2545277" y="2228842"/>
            <a:ext cx="351692" cy="452176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2144AD6-CACD-0C53-F35F-CA8BA1EC1EDF}"/>
              </a:ext>
            </a:extLst>
          </p:cNvPr>
          <p:cNvSpPr txBox="1"/>
          <p:nvPr/>
        </p:nvSpPr>
        <p:spPr>
          <a:xfrm>
            <a:off x="-20735" y="55255"/>
            <a:ext cx="9159033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ja-JP" sz="2000">
                <a:effectLst/>
                <a:latin typeface="Arial" panose="020B0604020202020204" pitchFamily="34" charset="0"/>
                <a:ea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en-US" altLang="ja-JP" sz="2000" dirty="0">
                <a:effectLst/>
                <a:latin typeface="Arial" panose="020B0604020202020204" pitchFamily="34" charset="0"/>
                <a:ea typeface="Palatino Linotype" panose="02040502050505030304" pitchFamily="18" charset="0"/>
                <a:cs typeface="Arial" panose="020B0604020202020204" pitchFamily="34" charset="0"/>
              </a:rPr>
              <a:t>Supplemental Figure S1:  Procedure for bio-priming by PNSB in the field study</a:t>
            </a:r>
            <a:r>
              <a:rPr lang="ja-JP" altLang="ja-JP" sz="200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BBAD0B19-A124-E1F5-E74D-5E95B33B455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6594" y="1428593"/>
            <a:ext cx="2367376" cy="2052673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9715AA1C-B7A1-F426-D620-CB41682FAF6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-915"/>
          <a:stretch/>
        </p:blipFill>
        <p:spPr>
          <a:xfrm>
            <a:off x="608621" y="4458308"/>
            <a:ext cx="2439480" cy="2257461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6FC8A32-04E0-394E-F6E9-8F0FE303ACD4}"/>
              </a:ext>
            </a:extLst>
          </p:cNvPr>
          <p:cNvSpPr txBox="1"/>
          <p:nvPr/>
        </p:nvSpPr>
        <p:spPr>
          <a:xfrm>
            <a:off x="372700" y="907354"/>
            <a:ext cx="15518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ja-JP" sz="2000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R</a:t>
            </a:r>
            <a:r>
              <a:rPr kumimoji="0" lang="en" altLang="ja-JP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ice seeds</a:t>
            </a:r>
            <a:endParaRPr kumimoji="1" lang="ja-JP" altLang="en-US" sz="2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7A35DB61-F6FA-3A67-A228-01715A80EDEB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851" r="4579" b="1907"/>
          <a:stretch/>
        </p:blipFill>
        <p:spPr>
          <a:xfrm>
            <a:off x="3720491" y="4432182"/>
            <a:ext cx="2590202" cy="2247543"/>
          </a:xfrm>
          <a:prstGeom prst="rect">
            <a:avLst/>
          </a:prstGeom>
        </p:spPr>
      </p:pic>
      <p:sp>
        <p:nvSpPr>
          <p:cNvPr id="2" name="右矢印 1">
            <a:extLst>
              <a:ext uri="{FF2B5EF4-FFF2-40B4-BE49-F238E27FC236}">
                <a16:creationId xmlns:a16="http://schemas.microsoft.com/office/drawing/2014/main" id="{81466A08-CA50-4465-0BEB-BC46D81D1085}"/>
              </a:ext>
            </a:extLst>
          </p:cNvPr>
          <p:cNvSpPr/>
          <p:nvPr/>
        </p:nvSpPr>
        <p:spPr>
          <a:xfrm>
            <a:off x="113542" y="5209040"/>
            <a:ext cx="351692" cy="440613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DF51B53-EEE6-6FAB-C9F5-356FEBFD89AD}"/>
              </a:ext>
            </a:extLst>
          </p:cNvPr>
          <p:cNvSpPr txBox="1"/>
          <p:nvPr/>
        </p:nvSpPr>
        <p:spPr>
          <a:xfrm>
            <a:off x="200041" y="3750423"/>
            <a:ext cx="345464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ja-JP" sz="2000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Adding PNSB to water (final concentration: 10</a:t>
            </a:r>
            <a:r>
              <a:rPr lang="en" altLang="ja-JP" sz="2000" baseline="30000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5</a:t>
            </a:r>
            <a:r>
              <a:rPr lang="en" altLang="ja-JP" sz="2000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 </a:t>
            </a:r>
            <a:r>
              <a:rPr lang="en" altLang="ja-JP" sz="2000" dirty="0" err="1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cuf</a:t>
            </a:r>
            <a:r>
              <a:rPr lang="en" altLang="ja-JP" sz="2000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/mL)</a:t>
            </a:r>
            <a:endParaRPr kumimoji="1" lang="ja-JP" altLang="en-US" sz="2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0" name="右矢印 9">
            <a:extLst>
              <a:ext uri="{FF2B5EF4-FFF2-40B4-BE49-F238E27FC236}">
                <a16:creationId xmlns:a16="http://schemas.microsoft.com/office/drawing/2014/main" id="{2AE7E37A-402B-7574-8371-7E159D83BF88}"/>
              </a:ext>
            </a:extLst>
          </p:cNvPr>
          <p:cNvSpPr/>
          <p:nvPr/>
        </p:nvSpPr>
        <p:spPr>
          <a:xfrm>
            <a:off x="3208450" y="5134863"/>
            <a:ext cx="351692" cy="452176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4EEEB3B-2408-DD52-C3BF-96387862F1FF}"/>
              </a:ext>
            </a:extLst>
          </p:cNvPr>
          <p:cNvSpPr txBox="1"/>
          <p:nvPr/>
        </p:nvSpPr>
        <p:spPr>
          <a:xfrm>
            <a:off x="3654687" y="3945295"/>
            <a:ext cx="32030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ja-JP" sz="2000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io-priming for 24 hours</a:t>
            </a:r>
            <a:endParaRPr kumimoji="1" lang="ja-JP" altLang="en-US" sz="2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8" name="右矢印 17">
            <a:extLst>
              <a:ext uri="{FF2B5EF4-FFF2-40B4-BE49-F238E27FC236}">
                <a16:creationId xmlns:a16="http://schemas.microsoft.com/office/drawing/2014/main" id="{B0DD721A-1908-0D5A-1E29-9E0363E1DE9C}"/>
              </a:ext>
            </a:extLst>
          </p:cNvPr>
          <p:cNvSpPr/>
          <p:nvPr/>
        </p:nvSpPr>
        <p:spPr>
          <a:xfrm>
            <a:off x="5949237" y="2228474"/>
            <a:ext cx="351692" cy="440613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F236F1D7-30B0-0404-9A94-57768ACD99FD}"/>
              </a:ext>
            </a:extLst>
          </p:cNvPr>
          <p:cNvSpPr txBox="1"/>
          <p:nvPr/>
        </p:nvSpPr>
        <p:spPr>
          <a:xfrm>
            <a:off x="6857716" y="4982317"/>
            <a:ext cx="2228901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kern="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</a:t>
            </a:r>
            <a:r>
              <a:rPr lang="en-US" altLang="ja-JP" sz="20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owing the seed</a:t>
            </a:r>
          </a:p>
          <a:p>
            <a:r>
              <a:rPr lang="en-US" altLang="ja-JP" sz="2000" kern="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(next page)</a:t>
            </a:r>
            <a:endParaRPr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右矢印 22">
            <a:extLst>
              <a:ext uri="{FF2B5EF4-FFF2-40B4-BE49-F238E27FC236}">
                <a16:creationId xmlns:a16="http://schemas.microsoft.com/office/drawing/2014/main" id="{411C9290-2D3A-8FE0-3230-857691B59E0D}"/>
              </a:ext>
            </a:extLst>
          </p:cNvPr>
          <p:cNvSpPr/>
          <p:nvPr/>
        </p:nvSpPr>
        <p:spPr>
          <a:xfrm>
            <a:off x="6438606" y="5134863"/>
            <a:ext cx="351692" cy="440613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85139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右矢印 19">
            <a:extLst>
              <a:ext uri="{FF2B5EF4-FFF2-40B4-BE49-F238E27FC236}">
                <a16:creationId xmlns:a16="http://schemas.microsoft.com/office/drawing/2014/main" id="{97B67B1F-5FF7-F94E-954B-D3AA186BBB5D}"/>
              </a:ext>
            </a:extLst>
          </p:cNvPr>
          <p:cNvSpPr/>
          <p:nvPr/>
        </p:nvSpPr>
        <p:spPr>
          <a:xfrm>
            <a:off x="5714021" y="1670246"/>
            <a:ext cx="351692" cy="440613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89717D2B-B6A3-25DF-5A2D-DC5B35D6E689}"/>
              </a:ext>
            </a:extLst>
          </p:cNvPr>
          <p:cNvGrpSpPr/>
          <p:nvPr/>
        </p:nvGrpSpPr>
        <p:grpSpPr>
          <a:xfrm>
            <a:off x="334704" y="917518"/>
            <a:ext cx="5213479" cy="2397828"/>
            <a:chOff x="433559" y="1031172"/>
            <a:chExt cx="3549025" cy="1695673"/>
          </a:xfrm>
        </p:grpSpPr>
        <p:pic>
          <p:nvPicPr>
            <p:cNvPr id="14" name="図 13">
              <a:extLst>
                <a:ext uri="{FF2B5EF4-FFF2-40B4-BE49-F238E27FC236}">
                  <a16:creationId xmlns:a16="http://schemas.microsoft.com/office/drawing/2014/main" id="{4CAD7F3F-E08D-4F36-0A97-D32B01E5F6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433559" y="1031172"/>
              <a:ext cx="1400920" cy="1687791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="" xmlns:wpc="http://schemas.microsoft.com/office/word/2010/wordprocessingCanvas" xmlns:mo="http://schemas.microsoft.com/office/mac/office/2008/main" xmlns:mc="http://schemas.openxmlformats.org/markup-compatibility/2006" xmlns:mv="urn:schemas-microsoft-com:mac:vml" xmlns:o="urn:schemas-microsoft-com:office:office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pic="http://schemas.openxmlformats.org/drawingml/2006/picture" xmlns:a14="http://schemas.microsoft.com/office/drawing/2010/main" xmlns:lc="http://schemas.openxmlformats.org/drawingml/2006/lockedCanvas"/>
              </a:ext>
            </a:extLst>
          </p:spPr>
        </p:pic>
        <p:pic>
          <p:nvPicPr>
            <p:cNvPr id="15" name="図 14">
              <a:extLst>
                <a:ext uri="{FF2B5EF4-FFF2-40B4-BE49-F238E27FC236}">
                  <a16:creationId xmlns:a16="http://schemas.microsoft.com/office/drawing/2014/main" id="{57DD6371-2109-C01C-F2FF-F44D79D947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4388" t="5015"/>
            <a:stretch/>
          </p:blipFill>
          <p:spPr>
            <a:xfrm>
              <a:off x="1954268" y="1039054"/>
              <a:ext cx="2028316" cy="1687791"/>
            </a:xfrm>
            <a:prstGeom prst="rect">
              <a:avLst/>
            </a:prstGeom>
          </p:spPr>
        </p:pic>
      </p:grp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8EBB839B-7346-E450-3FC5-79695A8B8B7E}"/>
              </a:ext>
            </a:extLst>
          </p:cNvPr>
          <p:cNvSpPr txBox="1"/>
          <p:nvPr/>
        </p:nvSpPr>
        <p:spPr>
          <a:xfrm>
            <a:off x="825050" y="135274"/>
            <a:ext cx="4043512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kern="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</a:t>
            </a:r>
            <a:r>
              <a:rPr lang="en-US" altLang="ja-JP" sz="20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owing the seed onto a tray for germination and seedling growth</a:t>
            </a:r>
            <a:r>
              <a:rPr lang="ja-JP" altLang="ja-JP" sz="200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95CA4EBD-707C-7017-C6DF-42284959A558}"/>
              </a:ext>
            </a:extLst>
          </p:cNvPr>
          <p:cNvSpPr txBox="1"/>
          <p:nvPr/>
        </p:nvSpPr>
        <p:spPr>
          <a:xfrm>
            <a:off x="316134" y="3271506"/>
            <a:ext cx="2252475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ja-JP" sz="2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owing machine</a:t>
            </a:r>
            <a:endParaRPr lang="ja-JP" altLang="en-US" sz="2000"/>
          </a:p>
        </p:txBody>
      </p:sp>
      <p:pic>
        <p:nvPicPr>
          <p:cNvPr id="26" name="図 25">
            <a:extLst>
              <a:ext uri="{FF2B5EF4-FFF2-40B4-BE49-F238E27FC236}">
                <a16:creationId xmlns:a16="http://schemas.microsoft.com/office/drawing/2014/main" id="{1934D30F-7062-B1F4-8911-50BEBC84D1D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2192" t="5198" r="3713" b="9313"/>
          <a:stretch/>
        </p:blipFill>
        <p:spPr>
          <a:xfrm>
            <a:off x="6231551" y="917518"/>
            <a:ext cx="2745264" cy="2375536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A98CDF08-8B97-6D1F-E738-82718F22994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4188" t="-1" b="2372"/>
          <a:stretch/>
        </p:blipFill>
        <p:spPr>
          <a:xfrm>
            <a:off x="5543628" y="3967391"/>
            <a:ext cx="3146131" cy="2684503"/>
          </a:xfrm>
          <a:prstGeom prst="rect">
            <a:avLst/>
          </a:prstGeom>
        </p:spPr>
      </p:pic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7B18A46A-256D-817B-A135-569C0725D8A2}"/>
              </a:ext>
            </a:extLst>
          </p:cNvPr>
          <p:cNvSpPr txBox="1"/>
          <p:nvPr/>
        </p:nvSpPr>
        <p:spPr>
          <a:xfrm>
            <a:off x="2888303" y="3538162"/>
            <a:ext cx="539322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ja-JP" sz="2000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Planting rice seedlings to flooded paddy field</a:t>
            </a:r>
            <a:endParaRPr kumimoji="1" lang="ja-JP" altLang="en-US" sz="2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pic>
        <p:nvPicPr>
          <p:cNvPr id="29" name="図 28">
            <a:extLst>
              <a:ext uri="{FF2B5EF4-FFF2-40B4-BE49-F238E27FC236}">
                <a16:creationId xmlns:a16="http://schemas.microsoft.com/office/drawing/2014/main" id="{1D064F13-C5E3-8E5C-93A2-6D3E85F8267B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2094" t="10610" r="14864" b="5334"/>
          <a:stretch/>
        </p:blipFill>
        <p:spPr>
          <a:xfrm>
            <a:off x="2712334" y="3967391"/>
            <a:ext cx="2676575" cy="2676577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AE5431C-FDF4-05E0-C69B-FA89CA42319C}"/>
              </a:ext>
            </a:extLst>
          </p:cNvPr>
          <p:cNvSpPr txBox="1"/>
          <p:nvPr/>
        </p:nvSpPr>
        <p:spPr>
          <a:xfrm>
            <a:off x="6518606" y="421847"/>
            <a:ext cx="21711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" altLang="ja-JP" sz="2000" dirty="0">
                <a:solidFill>
                  <a:prstClr val="black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After one month</a:t>
            </a:r>
            <a:endParaRPr kumimoji="1" lang="ja-JP" altLang="en-US" sz="2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25" name="右矢印 24">
            <a:extLst>
              <a:ext uri="{FF2B5EF4-FFF2-40B4-BE49-F238E27FC236}">
                <a16:creationId xmlns:a16="http://schemas.microsoft.com/office/drawing/2014/main" id="{432DA119-2014-0E7E-541D-C5FFC9AF35D3}"/>
              </a:ext>
            </a:extLst>
          </p:cNvPr>
          <p:cNvSpPr/>
          <p:nvPr/>
        </p:nvSpPr>
        <p:spPr>
          <a:xfrm>
            <a:off x="1813390" y="4865066"/>
            <a:ext cx="351692" cy="440613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34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30205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33</TotalTime>
  <Words>76</Words>
  <Application>Microsoft Macintosh PowerPoint</Application>
  <PresentationFormat>画面に合わせる (4:3)</PresentationFormat>
  <Paragraphs>14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坂 研究室</dc:creator>
  <cp:lastModifiedBy>宮坂均</cp:lastModifiedBy>
  <cp:revision>22</cp:revision>
  <dcterms:created xsi:type="dcterms:W3CDTF">2022-09-23T04:39:23Z</dcterms:created>
  <dcterms:modified xsi:type="dcterms:W3CDTF">2022-11-01T10:16:08Z</dcterms:modified>
</cp:coreProperties>
</file>